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0" r:id="rId3"/>
    <p:sldId id="258" r:id="rId4"/>
    <p:sldId id="264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14"/>
    <p:restoredTop sz="94613"/>
  </p:normalViewPr>
  <p:slideViewPr>
    <p:cSldViewPr snapToGrid="0" snapToObjects="1">
      <p:cViewPr>
        <p:scale>
          <a:sx n="144" d="100"/>
          <a:sy n="144" d="100"/>
        </p:scale>
        <p:origin x="-72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8CC3439-E379-E247-AA18-8CE07DAFA2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72FF36A0-51E8-2848-94ED-F781637797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quez pour modifier le style des sous-titres du masque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B12681B0-102E-714F-9B69-9BAC8F503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1E30FA1-F2DA-004A-8545-8D76AB2A5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3EE5127-968B-E848-A47B-B012DD7E8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981232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E25B656-4968-7E46-B028-1B873DD94B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83BB87CF-94E2-8A4C-8846-A8A4E9652E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9413F72C-7F84-B649-9AFA-E2A57FBB2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ACCAB0D7-A509-3F4B-A29D-7635D3D04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CFD607C-3AE3-B747-BABB-A5831A282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357791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A0F9A631-7FD1-BD4A-A67E-5A82F3E36E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3D353E08-05D5-6C42-A0FF-010F9FD0BE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719A799-4ADE-6F48-8875-B75CF0C25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9750AFE-B7E6-9448-A7CD-DE4A8AD87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8F39F98-9D48-374C-9BE8-44CE9167D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1098173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3569ECD-7790-BF47-91BE-36E223F5A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2B11D23F-E2CF-0945-8A49-472BD60202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B9EBB736-6F21-F04B-A03A-E7A6CB2AD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F8182928-C926-0349-ACEC-D2E7F9D10F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6BBAA6E0-F558-B840-A56D-F54C2487E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458797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E22A2DC2-1956-664C-81C0-21EB7E31B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1D14CCD7-6238-7449-B737-B73CE11FE2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BC317B5C-1ED3-F748-859E-6F81ECCE6F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A493C07-F7AE-BB48-9EE6-90C323B6E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DE91D96-A90B-154C-97E0-F43BA39E2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173351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09BB7A34-9344-2242-B3A3-289462E53D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E7E57E67-422C-C245-9F21-EA8C5757E0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A77F4F6A-0354-BF48-BF21-7AAD648B15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6BEC1E82-5DF9-054C-96BE-16B812D1F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4C7C1BA-5ECE-B641-B6D2-5B825B2F7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D60A19F0-685F-D746-9539-1BDC10A36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814347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BE3DA472-7A2E-0447-BAA2-90E22F5404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7240DF5A-254A-8642-A86C-6DCA5648C9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16951906-BE4E-FC47-9B34-FBD111631B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5BF4D376-DEDE-5541-8B5D-4EE6210E9C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F6BA801D-0F9F-B945-8BB0-7D6F91363C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4220DF0F-A187-684A-83CC-2661966F3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022D40EC-338C-AD4F-B7A2-56BF64FB1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39B5BB0B-7AA2-4741-B645-1CEA2D5F7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72246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414021F9-D274-4D47-B37F-3EDB8929B1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D7A37763-15F4-304E-9582-A19760116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BDF8D7CB-D936-DC44-91EF-3F8278BBB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CD31A0E6-AA93-3941-A515-8FD6395C0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249373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835E7D4C-A78C-7F40-A434-6C8EAEC2F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5B358A5A-9C54-824F-9D3F-BC485B3B0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68DCF68A-FA34-494D-B4CA-8B34E728F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262486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C556C81-452B-0F45-9EA7-889F1F71F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9F6FDEA6-43FE-1E4D-8A0D-E9168888EA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9B5471F5-86C8-0046-B46E-7D04E36788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CD1F9E3A-DC50-D745-B30F-72866EE74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529FAD1C-2288-7F42-AC62-A78169F05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FD8348AA-BD4F-2047-AF65-B786FC6C7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641261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8B7D2B9-04DE-E44B-8E18-DDE71085F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e l’image 2">
            <a:extLst>
              <a:ext uri="{FF2B5EF4-FFF2-40B4-BE49-F238E27FC236}">
                <a16:creationId xmlns:a16="http://schemas.microsoft.com/office/drawing/2014/main" xmlns="" id="{7596B1C6-CEA2-054E-BB50-F83DA6F8A7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2B1803E-E642-344C-80DF-D9F149EF55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99BC8E22-6D7B-8E44-9238-CDD15CCD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E602D896-33C1-444C-AAF4-952DBCD7F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B351086E-5D2C-3E4E-82C5-3DDF867E6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917127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D7D5DA4D-3F6D-9442-B470-F72D36F1E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9D6EDE0C-EC5B-2E49-A39F-BF45100F9F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45F731C-57A5-9D47-9077-2CE5252786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6B2EA-5DFC-AA4B-9BEF-72C7C86E8C1B}" type="datetimeFigureOut">
              <a:rPr lang="en-CA" smtClean="0"/>
              <a:pPr/>
              <a:t>26/07/2018</a:t>
            </a:fld>
            <a:endParaRPr lang="en-CA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116EFB7-D781-6A40-B62C-AC0E193A6A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A47358E-793C-4747-9EF8-5C61660AD7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9D022-617F-D742-BE59-76F239C749F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854381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EA043D3-2743-FF46-89EC-96D159369EB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CA" dirty="0"/>
              <a:t>Supplemental figures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6F2E180A-6AEE-F545-B644-FB45C8AD57F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16682244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60AE67E3-3A16-524A-B312-A8626EF5AF7C}"/>
              </a:ext>
            </a:extLst>
          </p:cNvPr>
          <p:cNvSpPr txBox="1"/>
          <p:nvPr/>
        </p:nvSpPr>
        <p:spPr>
          <a:xfrm>
            <a:off x="1386348" y="545690"/>
            <a:ext cx="1113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1.</a:t>
            </a:r>
            <a:endParaRPr lang="fr-FR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754D6AFF-9F1A-6941-A324-44EFEE19B2B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 bwMode="auto">
          <a:xfrm>
            <a:off x="1367244" y="2153529"/>
            <a:ext cx="4235450" cy="349377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F0053024-3952-A947-8F34-60D2C0677087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 bwMode="auto">
          <a:xfrm>
            <a:off x="5976791" y="2153529"/>
            <a:ext cx="4285673" cy="353568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ZoneTexte 3">
            <a:extLst>
              <a:ext uri="{FF2B5EF4-FFF2-40B4-BE49-F238E27FC236}">
                <a16:creationId xmlns:a16="http://schemas.microsoft.com/office/drawing/2014/main" xmlns="" id="{E95D3D01-FFFA-B649-9960-09741B1F1E6F}"/>
              </a:ext>
            </a:extLst>
          </p:cNvPr>
          <p:cNvSpPr txBox="1"/>
          <p:nvPr/>
        </p:nvSpPr>
        <p:spPr>
          <a:xfrm>
            <a:off x="1367244" y="1903742"/>
            <a:ext cx="270510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CA" sz="1100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ZoneTexte 4">
            <a:extLst>
              <a:ext uri="{FF2B5EF4-FFF2-40B4-BE49-F238E27FC236}">
                <a16:creationId xmlns:a16="http://schemas.microsoft.com/office/drawing/2014/main" xmlns="" id="{35E790A0-C625-8744-B029-0234FCD736E7}"/>
              </a:ext>
            </a:extLst>
          </p:cNvPr>
          <p:cNvSpPr txBox="1"/>
          <p:nvPr/>
        </p:nvSpPr>
        <p:spPr>
          <a:xfrm>
            <a:off x="5976791" y="1898264"/>
            <a:ext cx="268605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CA" sz="1100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014255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>
            <a:extLst>
              <a:ext uri="{FF2B5EF4-FFF2-40B4-BE49-F238E27FC236}">
                <a16:creationId xmlns:a16="http://schemas.microsoft.com/office/drawing/2014/main" xmlns="" id="{3F1F0DEF-8D5E-401B-A466-7778C695AB9E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990" b="12020"/>
          <a:stretch/>
        </p:blipFill>
        <p:spPr bwMode="auto">
          <a:xfrm>
            <a:off x="1541312" y="2328862"/>
            <a:ext cx="4331772" cy="3008451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14DE83FD-D517-C34C-BAB7-0B472E715D38}"/>
              </a:ext>
            </a:extLst>
          </p:cNvPr>
          <p:cNvSpPr txBox="1"/>
          <p:nvPr/>
        </p:nvSpPr>
        <p:spPr>
          <a:xfrm>
            <a:off x="1386348" y="545690"/>
            <a:ext cx="1113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2.</a:t>
            </a:r>
            <a:endParaRPr lang="fr-FR"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DCCB0C9F-3C64-F542-A7D5-345BD7046DC2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990" t="92349"/>
          <a:stretch/>
        </p:blipFill>
        <p:spPr bwMode="auto">
          <a:xfrm>
            <a:off x="1541312" y="5566239"/>
            <a:ext cx="4331772" cy="26161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51D1D0EE-BB80-3A44-9A12-6DA42DE4AFF0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938" t="91718"/>
          <a:stretch/>
        </p:blipFill>
        <p:spPr bwMode="auto">
          <a:xfrm>
            <a:off x="6400800" y="5544863"/>
            <a:ext cx="4331772" cy="282986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ZoneTexte 3">
            <a:extLst>
              <a:ext uri="{FF2B5EF4-FFF2-40B4-BE49-F238E27FC236}">
                <a16:creationId xmlns:a16="http://schemas.microsoft.com/office/drawing/2014/main" xmlns="" id="{EDF15FE5-6C7C-1D4A-A841-7E671D7DF33D}"/>
              </a:ext>
            </a:extLst>
          </p:cNvPr>
          <p:cNvSpPr txBox="1"/>
          <p:nvPr/>
        </p:nvSpPr>
        <p:spPr>
          <a:xfrm>
            <a:off x="1367244" y="1903742"/>
            <a:ext cx="270510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CA" sz="1100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ZoneTexte 4">
            <a:extLst>
              <a:ext uri="{FF2B5EF4-FFF2-40B4-BE49-F238E27FC236}">
                <a16:creationId xmlns:a16="http://schemas.microsoft.com/office/drawing/2014/main" xmlns="" id="{A87AC55B-54CA-7B4C-A47A-0D84E48EDAC1}"/>
              </a:ext>
            </a:extLst>
          </p:cNvPr>
          <p:cNvSpPr txBox="1"/>
          <p:nvPr/>
        </p:nvSpPr>
        <p:spPr>
          <a:xfrm>
            <a:off x="6217421" y="1898264"/>
            <a:ext cx="268605" cy="255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CA" sz="1100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xmlns="" id="{C4E55234-27C9-4DAA-A625-403634AC4097}"/>
              </a:ext>
            </a:extLst>
          </p:cNvPr>
          <p:cNvSpPr txBox="1"/>
          <p:nvPr/>
        </p:nvSpPr>
        <p:spPr>
          <a:xfrm rot="16200000">
            <a:off x="5244738" y="3677365"/>
            <a:ext cx="205043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100" dirty="0"/>
              <a:t>VE-induced change in </a:t>
            </a:r>
            <a:r>
              <a:rPr lang="en-CA" sz="1100" dirty="0" err="1"/>
              <a:t>VTIao</a:t>
            </a:r>
            <a:r>
              <a:rPr lang="en-CA" sz="1100" dirty="0"/>
              <a:t> (%)</a:t>
            </a:r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xmlns="" id="{38C65CEE-1D24-4593-BEEC-8E1E75240B2F}"/>
              </a:ext>
            </a:extLst>
          </p:cNvPr>
          <p:cNvSpPr/>
          <p:nvPr/>
        </p:nvSpPr>
        <p:spPr>
          <a:xfrm>
            <a:off x="4973866" y="5152564"/>
            <a:ext cx="168218" cy="17800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Ellipse 10">
            <a:extLst>
              <a:ext uri="{FF2B5EF4-FFF2-40B4-BE49-F238E27FC236}">
                <a16:creationId xmlns:a16="http://schemas.microsoft.com/office/drawing/2014/main" xmlns="" id="{EE8276AC-DCA8-4CF8-A22B-7CE831031899}"/>
              </a:ext>
            </a:extLst>
          </p:cNvPr>
          <p:cNvSpPr/>
          <p:nvPr/>
        </p:nvSpPr>
        <p:spPr>
          <a:xfrm>
            <a:off x="6480312" y="2425595"/>
            <a:ext cx="168218" cy="17800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1BFDE448-6FD4-4CA9-81EB-BEBB33BAD1BD}"/>
              </a:ext>
            </a:extLst>
          </p:cNvPr>
          <p:cNvSpPr txBox="1"/>
          <p:nvPr/>
        </p:nvSpPr>
        <p:spPr>
          <a:xfrm rot="16200000">
            <a:off x="414331" y="3677365"/>
            <a:ext cx="205043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100" dirty="0"/>
              <a:t>VE-induced change in </a:t>
            </a:r>
            <a:r>
              <a:rPr lang="en-CA" sz="1100" dirty="0" err="1"/>
              <a:t>VTIao</a:t>
            </a:r>
            <a:r>
              <a:rPr lang="en-CA" sz="1100" dirty="0"/>
              <a:t> (%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xmlns="" id="{50B6ECC7-A98C-4273-8BE1-EFDE9DC074A9}"/>
              </a:ext>
            </a:extLst>
          </p:cNvPr>
          <p:cNvSpPr txBox="1"/>
          <p:nvPr/>
        </p:nvSpPr>
        <p:spPr>
          <a:xfrm>
            <a:off x="7240749" y="5310695"/>
            <a:ext cx="205043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100" dirty="0" err="1"/>
              <a:t>iIVC-st</a:t>
            </a:r>
            <a:r>
              <a:rPr lang="en-CA" sz="1100" dirty="0"/>
              <a:t> (mm)</a:t>
            </a: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xmlns="" id="{35054866-9A48-4BBE-A1C4-9B9A493092CB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938" b="11955"/>
          <a:stretch/>
        </p:blipFill>
        <p:spPr bwMode="auto">
          <a:xfrm>
            <a:off x="6400800" y="2328862"/>
            <a:ext cx="4331772" cy="3008451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Ellipse 16">
            <a:extLst>
              <a:ext uri="{FF2B5EF4-FFF2-40B4-BE49-F238E27FC236}">
                <a16:creationId xmlns:a16="http://schemas.microsoft.com/office/drawing/2014/main" xmlns="" id="{F6482A8B-2CEA-4571-B233-16D305E9B245}"/>
              </a:ext>
            </a:extLst>
          </p:cNvPr>
          <p:cNvSpPr/>
          <p:nvPr/>
        </p:nvSpPr>
        <p:spPr>
          <a:xfrm>
            <a:off x="1561190" y="2445026"/>
            <a:ext cx="168218" cy="17800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Ellipse 17">
            <a:extLst>
              <a:ext uri="{FF2B5EF4-FFF2-40B4-BE49-F238E27FC236}">
                <a16:creationId xmlns:a16="http://schemas.microsoft.com/office/drawing/2014/main" xmlns="" id="{9A6FF262-1830-409D-98EC-E4CC6F88382D}"/>
              </a:ext>
            </a:extLst>
          </p:cNvPr>
          <p:cNvSpPr/>
          <p:nvPr/>
        </p:nvSpPr>
        <p:spPr>
          <a:xfrm>
            <a:off x="6486026" y="2429356"/>
            <a:ext cx="168218" cy="17800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Ellipse 18">
            <a:extLst>
              <a:ext uri="{FF2B5EF4-FFF2-40B4-BE49-F238E27FC236}">
                <a16:creationId xmlns:a16="http://schemas.microsoft.com/office/drawing/2014/main" xmlns="" id="{CBFE4394-6271-4B52-8DE6-D8886815EEAE}"/>
              </a:ext>
            </a:extLst>
          </p:cNvPr>
          <p:cNvSpPr/>
          <p:nvPr/>
        </p:nvSpPr>
        <p:spPr>
          <a:xfrm>
            <a:off x="9553033" y="5159304"/>
            <a:ext cx="168218" cy="178009"/>
          </a:xfrm>
          <a:prstGeom prst="ellips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xmlns="" id="{299A2C6E-B9E1-4C7B-8E03-1C7F27E2672B}"/>
              </a:ext>
            </a:extLst>
          </p:cNvPr>
          <p:cNvSpPr txBox="1"/>
          <p:nvPr/>
        </p:nvSpPr>
        <p:spPr>
          <a:xfrm>
            <a:off x="2440160" y="5310695"/>
            <a:ext cx="2050437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1100" dirty="0" err="1"/>
              <a:t>cIVC-st</a:t>
            </a:r>
            <a:r>
              <a:rPr lang="en-CA" sz="1100" dirty="0"/>
              <a:t> (%)</a:t>
            </a:r>
          </a:p>
        </p:txBody>
      </p:sp>
    </p:spTree>
    <p:extLst>
      <p:ext uri="{BB962C8B-B14F-4D97-AF65-F5344CB8AC3E}">
        <p14:creationId xmlns:p14="http://schemas.microsoft.com/office/powerpoint/2010/main" xmlns="" val="31960219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>
            <a:extLst>
              <a:ext uri="{FF2B5EF4-FFF2-40B4-BE49-F238E27FC236}">
                <a16:creationId xmlns:a16="http://schemas.microsoft.com/office/drawing/2014/main" xmlns="" id="{59CB4B33-BDDF-104D-94B6-518266E2AC6E}"/>
              </a:ext>
            </a:extLst>
          </p:cNvPr>
          <p:cNvGrpSpPr/>
          <p:nvPr/>
        </p:nvGrpSpPr>
        <p:grpSpPr>
          <a:xfrm>
            <a:off x="3704511" y="1786268"/>
            <a:ext cx="4782977" cy="3285465"/>
            <a:chOff x="0" y="0"/>
            <a:chExt cx="6973889" cy="4813300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xmlns="" id="{E54C52BE-F55A-EA40-A387-56B10C19197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406651" y="0"/>
              <a:ext cx="3390900" cy="4813300"/>
            </a:xfrm>
            <a:prstGeom prst="rect">
              <a:avLst/>
            </a:prstGeom>
          </p:spPr>
        </p:pic>
        <p:pic>
          <p:nvPicPr>
            <p:cNvPr id="4" name="Image 3">
              <a:extLst>
                <a:ext uri="{FF2B5EF4-FFF2-40B4-BE49-F238E27FC236}">
                  <a16:creationId xmlns:a16="http://schemas.microsoft.com/office/drawing/2014/main" xmlns="" id="{7BC07F18-CE65-184F-BBE8-B888F91142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827589" y="0"/>
              <a:ext cx="2146300" cy="4813300"/>
            </a:xfrm>
            <a:prstGeom prst="rect">
              <a:avLst/>
            </a:prstGeom>
          </p:spPr>
        </p:pic>
        <p:pic>
          <p:nvPicPr>
            <p:cNvPr id="5" name="Image 4">
              <a:extLst>
                <a:ext uri="{FF2B5EF4-FFF2-40B4-BE49-F238E27FC236}">
                  <a16:creationId xmlns:a16="http://schemas.microsoft.com/office/drawing/2014/main" xmlns="" id="{5C94FB28-F3E1-8D4C-A892-8F9DDD35AEC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2146300" cy="4813300"/>
            </a:xfrm>
            <a:prstGeom prst="rect">
              <a:avLst/>
            </a:prstGeom>
          </p:spPr>
        </p:pic>
      </p:grp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B9124A50-C38D-F642-9110-8509ACCD8A88}"/>
              </a:ext>
            </a:extLst>
          </p:cNvPr>
          <p:cNvSpPr txBox="1"/>
          <p:nvPr/>
        </p:nvSpPr>
        <p:spPr>
          <a:xfrm>
            <a:off x="1386348" y="545690"/>
            <a:ext cx="1113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3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xmlns="" val="25477719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4</TotalTime>
  <Words>31</Words>
  <Application>Microsoft Office PowerPoint</Application>
  <PresentationFormat>Custom</PresentationFormat>
  <Paragraphs>1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Thème Office</vt:lpstr>
      <vt:lpstr>Supplemental figures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Perrine Bortolotti</dc:creator>
  <cp:lastModifiedBy>0002486</cp:lastModifiedBy>
  <cp:revision>24</cp:revision>
  <dcterms:created xsi:type="dcterms:W3CDTF">2018-01-30T02:56:54Z</dcterms:created>
  <dcterms:modified xsi:type="dcterms:W3CDTF">2018-07-26T07:37:03Z</dcterms:modified>
</cp:coreProperties>
</file>